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906000" cy="6858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810" autoAdjust="0"/>
    <p:restoredTop sz="94660"/>
  </p:normalViewPr>
  <p:slideViewPr>
    <p:cSldViewPr snapToGrid="0">
      <p:cViewPr>
        <p:scale>
          <a:sx n="100" d="100"/>
          <a:sy n="100" d="100"/>
        </p:scale>
        <p:origin x="-180" y="-7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68D96E-0CED-46F6-A409-C96367EDD023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917210-454A-488C-AA18-C1CBB9BA7F0F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81741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it-IT" b="1" dirty="0" smtClean="0">
                <a:latin typeface="Times New Roman" pitchFamily="18" charset="0"/>
                <a:cs typeface="Times New Roman" pitchFamily="18" charset="0"/>
              </a:rPr>
              <a:t>Rarefaction curves generated for 16S rRNA gene sequences obtained from the </a:t>
            </a:r>
            <a:r>
              <a:rPr lang="it-IT" b="1" baseline="0" dirty="0" smtClean="0">
                <a:latin typeface="Times New Roman" pitchFamily="18" charset="0"/>
                <a:cs typeface="Times New Roman" pitchFamily="18" charset="0"/>
              </a:rPr>
              <a:t>samples</a:t>
            </a:r>
            <a:r>
              <a:rPr lang="it-IT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it-IT" b="0" dirty="0" smtClean="0">
                <a:latin typeface="Times New Roman" pitchFamily="18" charset="0"/>
                <a:cs typeface="Times New Roman" pitchFamily="18" charset="0"/>
              </a:rPr>
              <a:t>Panel represents the rarefaction curves</a:t>
            </a:r>
            <a:r>
              <a:rPr lang="it-IT" b="0" baseline="0" dirty="0" smtClean="0">
                <a:latin typeface="Times New Roman" pitchFamily="18" charset="0"/>
                <a:cs typeface="Times New Roman" pitchFamily="18" charset="0"/>
              </a:rPr>
              <a:t> using the Chao1 index.</a:t>
            </a:r>
            <a:endParaRPr lang="it-IT" b="1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8917210-454A-488C-AA18-C1CBB9BA7F0F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56691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3971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8186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9819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21587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750084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7586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2282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76853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77377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01174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475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D864B1-54F8-43D9-ABE5-A270D60F0334}" type="datetimeFigureOut">
              <a:rPr lang="it-IT" smtClean="0"/>
              <a:t>26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5C1ECE-34F4-47F3-965A-0070694D253A}" type="slidenum">
              <a:rPr lang="it-IT" smtClean="0"/>
              <a:t>‹Nº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04258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4852262" y="6218756"/>
            <a:ext cx="1847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13 CuadroTexto"/>
          <p:cNvSpPr txBox="1"/>
          <p:nvPr/>
        </p:nvSpPr>
        <p:spPr>
          <a:xfrm>
            <a:off x="165961" y="138440"/>
            <a:ext cx="93725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refaction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curves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enerated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16S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RNA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btained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Chao1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ex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A) and Shannon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ex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B) </a:t>
            </a:r>
            <a:r>
              <a:rPr lang="es-ES" sz="140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s-ES" sz="1400" smtClean="0">
                <a:latin typeface="Arial" panose="020B0604020202020204" pitchFamily="34" charset="0"/>
                <a:cs typeface="Arial" panose="020B0604020202020204" pitchFamily="34" charset="0"/>
              </a:rPr>
              <a:t>observed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TUs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C)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16 Grupo"/>
          <p:cNvGrpSpPr/>
          <p:nvPr/>
        </p:nvGrpSpPr>
        <p:grpSpPr>
          <a:xfrm>
            <a:off x="28575" y="800100"/>
            <a:ext cx="9822643" cy="2800350"/>
            <a:chOff x="28575" y="1209675"/>
            <a:chExt cx="9822643" cy="2800350"/>
          </a:xfrm>
        </p:grpSpPr>
        <p:grpSp>
          <p:nvGrpSpPr>
            <p:cNvPr id="15" name="14 Grupo"/>
            <p:cNvGrpSpPr/>
            <p:nvPr/>
          </p:nvGrpSpPr>
          <p:grpSpPr>
            <a:xfrm>
              <a:off x="173038" y="1560514"/>
              <a:ext cx="9678180" cy="2449511"/>
              <a:chOff x="373063" y="1560514"/>
              <a:chExt cx="9678180" cy="2449511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73063" y="1560514"/>
                <a:ext cx="4731543" cy="244951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140326" y="1585638"/>
                <a:ext cx="4910917" cy="242438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16" name="15 CuadroTexto"/>
            <p:cNvSpPr txBox="1"/>
            <p:nvPr/>
          </p:nvSpPr>
          <p:spPr>
            <a:xfrm>
              <a:off x="28575" y="1209675"/>
              <a:ext cx="4381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 smtClean="0"/>
                <a:t>A</a:t>
              </a:r>
              <a:endParaRPr lang="es-ES" dirty="0"/>
            </a:p>
          </p:txBody>
        </p:sp>
        <p:sp>
          <p:nvSpPr>
            <p:cNvPr id="19" name="18 CuadroTexto"/>
            <p:cNvSpPr txBox="1"/>
            <p:nvPr/>
          </p:nvSpPr>
          <p:spPr>
            <a:xfrm>
              <a:off x="4686300" y="1209675"/>
              <a:ext cx="4381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B</a:t>
              </a:r>
            </a:p>
          </p:txBody>
        </p:sp>
      </p:grpSp>
      <p:grpSp>
        <p:nvGrpSpPr>
          <p:cNvPr id="4" name="3 Grupo"/>
          <p:cNvGrpSpPr/>
          <p:nvPr/>
        </p:nvGrpSpPr>
        <p:grpSpPr>
          <a:xfrm>
            <a:off x="2538809" y="3895725"/>
            <a:ext cx="4605022" cy="2725698"/>
            <a:chOff x="2538809" y="3895725"/>
            <a:chExt cx="4605022" cy="2725698"/>
          </a:xfrm>
        </p:grpSpPr>
        <p:sp>
          <p:nvSpPr>
            <p:cNvPr id="10" name="9 CuadroTexto"/>
            <p:cNvSpPr txBox="1"/>
            <p:nvPr/>
          </p:nvSpPr>
          <p:spPr>
            <a:xfrm>
              <a:off x="2538809" y="4036457"/>
              <a:ext cx="4381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dirty="0"/>
                <a:t>C</a:t>
              </a:r>
            </a:p>
          </p:txBody>
        </p:sp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76959" y="3895725"/>
              <a:ext cx="4166872" cy="272569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0431303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7</TotalTime>
  <Words>62</Words>
  <Application>Microsoft Office PowerPoint</Application>
  <PresentationFormat>A4 (210 x 297 mm)</PresentationFormat>
  <Paragraphs>6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o</dc:creator>
  <cp:lastModifiedBy>MGueimonde</cp:lastModifiedBy>
  <cp:revision>26</cp:revision>
  <dcterms:created xsi:type="dcterms:W3CDTF">2015-07-08T13:06:08Z</dcterms:created>
  <dcterms:modified xsi:type="dcterms:W3CDTF">2017-06-26T11:36:08Z</dcterms:modified>
</cp:coreProperties>
</file>